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691812"/>
  <p:notesSz cx="7772400" cy="10058400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698760" y="754560"/>
            <a:ext cx="6161400" cy="166572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698760" y="2691720"/>
            <a:ext cx="616140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698760" y="5714280"/>
            <a:ext cx="616140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98760" y="754560"/>
            <a:ext cx="6161400" cy="166572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698760" y="2691720"/>
            <a:ext cx="300672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856320" y="2691720"/>
            <a:ext cx="300672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698760" y="5714280"/>
            <a:ext cx="300672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856320" y="5714280"/>
            <a:ext cx="300672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698760" y="754560"/>
            <a:ext cx="6161400" cy="166572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698760" y="2691720"/>
            <a:ext cx="198360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782080" y="2691720"/>
            <a:ext cx="198360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865040" y="2691720"/>
            <a:ext cx="198360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698760" y="5714280"/>
            <a:ext cx="198360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782080" y="5714280"/>
            <a:ext cx="198360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865040" y="5714280"/>
            <a:ext cx="198360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98760" y="754560"/>
            <a:ext cx="6161400" cy="166572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698760" y="2691720"/>
            <a:ext cx="6161400" cy="57870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698760" y="754560"/>
            <a:ext cx="6161400" cy="166572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698760" y="2691720"/>
            <a:ext cx="6161400" cy="57870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98760" y="754560"/>
            <a:ext cx="6161400" cy="166572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698760" y="2691720"/>
            <a:ext cx="3006720" cy="57870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856320" y="2691720"/>
            <a:ext cx="3006720" cy="57870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98760" y="754560"/>
            <a:ext cx="6161400" cy="166572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698760" y="754560"/>
            <a:ext cx="6161400" cy="772272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698760" y="754560"/>
            <a:ext cx="6161400" cy="166572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698760" y="2691720"/>
            <a:ext cx="300672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856320" y="2691720"/>
            <a:ext cx="3006720" cy="57870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698760" y="5714280"/>
            <a:ext cx="300672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698760" y="754560"/>
            <a:ext cx="6161400" cy="166572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698760" y="2691720"/>
            <a:ext cx="3006720" cy="57870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856320" y="2691720"/>
            <a:ext cx="300672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856320" y="5714280"/>
            <a:ext cx="300672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698760" y="754560"/>
            <a:ext cx="6161400" cy="166572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698760" y="2691720"/>
            <a:ext cx="300672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856320" y="2691720"/>
            <a:ext cx="300672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698760" y="5714280"/>
            <a:ext cx="6161400" cy="276012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98760" y="754560"/>
            <a:ext cx="6161400" cy="166572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r>
              <a:rPr b="0" lang="en-US" sz="4400" spc="-1" strike="noStrike">
                <a:latin typeface="Arial"/>
              </a:rPr>
              <a:t>Clique para editar o formato do texto do título</a:t>
            </a:r>
            <a:endParaRPr b="0" lang="en-US" sz="4400" spc="-1" strike="noStrike"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98760" y="2691720"/>
            <a:ext cx="6161400" cy="57870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3200" spc="-1" strike="noStrike">
                <a:latin typeface="Arial"/>
              </a:rPr>
              <a:t>Clique para editar o formato do texto da estrutura de tópicos</a:t>
            </a:r>
            <a:endParaRPr b="0" lang="en-US" sz="3200" spc="-1" strike="noStrike"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US" sz="2800" spc="-1" strike="noStrike">
                <a:latin typeface="Arial"/>
              </a:rPr>
              <a:t>2.º nível da estrutura de tópicos</a:t>
            </a:r>
            <a:endParaRPr b="0" lang="en-US" sz="2800" spc="-1" strike="noStrike"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400" spc="-1" strike="noStrike">
                <a:latin typeface="Arial"/>
              </a:rPr>
              <a:t>3.º nível da estrutura de tópicos</a:t>
            </a:r>
            <a:endParaRPr b="0" lang="en-US" sz="2400" spc="-1" strike="noStrike"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US" sz="2000" spc="-1" strike="noStrike">
                <a:latin typeface="Arial"/>
              </a:rPr>
              <a:t>4.º nível da estrutura de tópicos</a:t>
            </a:r>
            <a:endParaRPr b="0" lang="en-US" sz="2000" spc="-1" strike="noStrike"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latin typeface="Arial"/>
              </a:rPr>
              <a:t>5.º nível da estrutura de tópicos</a:t>
            </a:r>
            <a:endParaRPr b="0" lang="en-US" sz="2000" spc="-1" strike="noStrike"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latin typeface="Arial"/>
              </a:rPr>
              <a:t>6.º nível da estrutura de tópicos</a:t>
            </a:r>
            <a:endParaRPr b="0" lang="en-US" sz="2000" spc="-1" strike="noStrike"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latin typeface="Arial"/>
              </a:rPr>
              <a:t>7.º nível da estrutura de tópicos</a:t>
            </a:r>
            <a:endParaRPr b="0" lang="en-US" sz="2000" spc="-1" strike="noStrike"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CustomShape 1"/>
          <p:cNvSpPr/>
          <p:nvPr/>
        </p:nvSpPr>
        <p:spPr>
          <a:xfrm>
            <a:off x="448200" y="7489080"/>
            <a:ext cx="6583680" cy="11887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 algn="just">
              <a:lnSpc>
                <a:spcPct val="100000"/>
              </a:lnSpc>
            </a:pPr>
            <a:r>
              <a:rPr b="1" lang="en-US" sz="1200" spc="-1" strike="noStrike">
                <a:solidFill>
                  <a:srgbClr val="202124"/>
                </a:solidFill>
                <a:latin typeface="Calibri"/>
                <a:ea typeface="Times New Roman"/>
              </a:rPr>
              <a:t>Supplementary Figure S3. Flowchart of the pipeline used to filter genetic variants.</a:t>
            </a:r>
            <a:r>
              <a:rPr b="0" lang="en-US" sz="1200" spc="-1" strike="noStrike">
                <a:solidFill>
                  <a:srgbClr val="202124"/>
                </a:solidFill>
                <a:latin typeface="Calibri"/>
                <a:ea typeface="Times New Roman"/>
              </a:rPr>
              <a:t> From WES fastq files were analyzed sequentially the variants using computational tools. The candidate variants were filtered by their mutation impact, low frequency using population databases, pathogenicity using ClinVar/ACMG rules, and classified according to clinical guidelines from phenotype annotation databases.</a:t>
            </a:r>
            <a:endParaRPr b="0" lang="en-US" sz="1200" spc="-1" strike="noStrike">
              <a:latin typeface="Arial"/>
            </a:endParaRPr>
          </a:p>
        </p:txBody>
      </p:sp>
      <p:pic>
        <p:nvPicPr>
          <p:cNvPr id="39" name="" descr=""/>
          <p:cNvPicPr/>
          <p:nvPr/>
        </p:nvPicPr>
        <p:blipFill>
          <a:blip r:embed="rId1"/>
          <a:stretch/>
        </p:blipFill>
        <p:spPr>
          <a:xfrm>
            <a:off x="516240" y="1083240"/>
            <a:ext cx="6447960" cy="6131520"/>
          </a:xfrm>
          <a:prstGeom prst="rect">
            <a:avLst/>
          </a:prstGeom>
          <a:ln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6.4.7.2$Linux_X86_64 LibreOffice_project/40$Build-2</Applicat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1-06T16:15:58Z</dcterms:created>
  <dc:creator/>
  <dc:description/>
  <dc:language>pt-BR</dc:language>
  <cp:lastModifiedBy/>
  <dcterms:modified xsi:type="dcterms:W3CDTF">2023-07-18T13:49:29Z</dcterms:modified>
  <cp:revision>8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5.0000</vt:lpwstr>
  </property>
</Properties>
</file>